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3CA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556" autoAdjust="0"/>
  </p:normalViewPr>
  <p:slideViewPr>
    <p:cSldViewPr>
      <p:cViewPr varScale="1">
        <p:scale>
          <a:sx n="85" d="100"/>
          <a:sy n="85" d="100"/>
        </p:scale>
        <p:origin x="1554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f-i-humgen.lumcnet.prod.intern\humgen\lab-j\pietro\papers\A_submitted\Pietro%20-%20Interactome\supplem%20figure%20support%20fil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vf-i-humgen.lumcnet.prod.intern\humgen\lab-j\pietro\papers\A_submitted\Pietro%20-%20Interactome\to%20submit\gen%20prot%20bioinf\revision%201\working%20files\DESeq_CL%20vs%20noCL_model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3"/>
          <c:order val="0"/>
          <c:tx>
            <c:strRef>
              <c:f>Sheet1!$A$144</c:f>
              <c:strCache>
                <c:ptCount val="1"/>
                <c:pt idx="0">
                  <c:v>MBNL1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Q$144:$R$14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.41421356237309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Sheet1!$N$1:$O$1</c:f>
              <c:strCache>
                <c:ptCount val="2"/>
                <c:pt idx="0">
                  <c:v>noCL</c:v>
                </c:pt>
                <c:pt idx="1">
                  <c:v>CL</c:v>
                </c:pt>
              </c:strCache>
            </c:strRef>
          </c:cat>
          <c:val>
            <c:numRef>
              <c:f>Sheet1!$N$144:$O$144</c:f>
              <c:numCache>
                <c:formatCode>General</c:formatCode>
                <c:ptCount val="2"/>
                <c:pt idx="0">
                  <c:v>0</c:v>
                </c:pt>
                <c:pt idx="1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73-4470-A3C1-A0DC5B71B53D}"/>
            </c:ext>
          </c:extLst>
        </c:ser>
        <c:ser>
          <c:idx val="4"/>
          <c:order val="1"/>
          <c:tx>
            <c:strRef>
              <c:f>Sheet1!$A$90</c:f>
              <c:strCache>
                <c:ptCount val="1"/>
                <c:pt idx="0">
                  <c:v>AGO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Q$90:$R$90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1213203435596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val>
            <c:numRef>
              <c:f>Sheet1!$N$90:$O$90</c:f>
              <c:numCache>
                <c:formatCode>General</c:formatCode>
                <c:ptCount val="2"/>
                <c:pt idx="0">
                  <c:v>0</c:v>
                </c:pt>
                <c:pt idx="1">
                  <c:v>1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973-4470-A3C1-A0DC5B71B53D}"/>
            </c:ext>
          </c:extLst>
        </c:ser>
        <c:ser>
          <c:idx val="1"/>
          <c:order val="2"/>
          <c:tx>
            <c:strRef>
              <c:f>Sheet1!$B$43</c:f>
              <c:strCache>
                <c:ptCount val="1"/>
                <c:pt idx="0">
                  <c:v>CELF2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Q$43:$R$43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12132034355964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Sheet1!$N$1:$O$1</c:f>
              <c:strCache>
                <c:ptCount val="2"/>
                <c:pt idx="0">
                  <c:v>noCL</c:v>
                </c:pt>
                <c:pt idx="1">
                  <c:v>CL</c:v>
                </c:pt>
              </c:strCache>
            </c:strRef>
          </c:cat>
          <c:val>
            <c:numRef>
              <c:f>Sheet1!$N$43:$O$43</c:f>
              <c:numCache>
                <c:formatCode>General</c:formatCode>
                <c:ptCount val="2"/>
                <c:pt idx="0">
                  <c:v>0</c:v>
                </c:pt>
                <c:pt idx="1">
                  <c:v>21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973-4470-A3C1-A0DC5B71B53D}"/>
            </c:ext>
          </c:extLst>
        </c:ser>
        <c:ser>
          <c:idx val="0"/>
          <c:order val="3"/>
          <c:tx>
            <c:strRef>
              <c:f>Sheet1!$A$6</c:f>
              <c:strCache>
                <c:ptCount val="1"/>
                <c:pt idx="0">
                  <c:v>HNRNPM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Q$6:$R$6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2.828427124746190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Sheet1!$N$1:$O$1</c:f>
              <c:strCache>
                <c:ptCount val="2"/>
                <c:pt idx="0">
                  <c:v>noCL</c:v>
                </c:pt>
                <c:pt idx="1">
                  <c:v>CL</c:v>
                </c:pt>
              </c:strCache>
            </c:strRef>
          </c:cat>
          <c:val>
            <c:numRef>
              <c:f>Sheet1!$N$6:$O$6</c:f>
              <c:numCache>
                <c:formatCode>General</c:formatCode>
                <c:ptCount val="2"/>
                <c:pt idx="0">
                  <c:v>0</c:v>
                </c:pt>
                <c:pt idx="1">
                  <c:v>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973-4470-A3C1-A0DC5B71B53D}"/>
            </c:ext>
          </c:extLst>
        </c:ser>
        <c:ser>
          <c:idx val="2"/>
          <c:order val="4"/>
          <c:tx>
            <c:strRef>
              <c:f>Sheet1!$B$2</c:f>
              <c:strCache>
                <c:ptCount val="1"/>
                <c:pt idx="0">
                  <c:v>HDLBP</c:v>
                </c:pt>
              </c:strCache>
            </c:strRef>
          </c:tx>
          <c:invertIfNegative val="0"/>
          <c:errBars>
            <c:errBarType val="plus"/>
            <c:errValType val="cust"/>
            <c:noEndCap val="0"/>
            <c:plus>
              <c:numRef>
                <c:f>Sheet1!$Q$2:$R$2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14.8492424049174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</c:errBars>
          <c:cat>
            <c:strRef>
              <c:f>Sheet1!$N$1:$O$1</c:f>
              <c:strCache>
                <c:ptCount val="2"/>
                <c:pt idx="0">
                  <c:v>noCL</c:v>
                </c:pt>
                <c:pt idx="1">
                  <c:v>CL</c:v>
                </c:pt>
              </c:strCache>
            </c:strRef>
          </c:cat>
          <c:val>
            <c:numRef>
              <c:f>Sheet1!$N$2:$O$2</c:f>
              <c:numCache>
                <c:formatCode>General</c:formatCode>
                <c:ptCount val="2"/>
                <c:pt idx="0">
                  <c:v>0</c:v>
                </c:pt>
                <c:pt idx="1">
                  <c:v>64.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1973-4470-A3C1-A0DC5B71B5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32241536"/>
        <c:axId val="332247424"/>
      </c:barChart>
      <c:catAx>
        <c:axId val="3322415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2247424"/>
        <c:crosses val="autoZero"/>
        <c:auto val="1"/>
        <c:lblAlgn val="ctr"/>
        <c:lblOffset val="100"/>
        <c:noMultiLvlLbl val="0"/>
      </c:catAx>
      <c:valAx>
        <c:axId val="33224742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332241536"/>
        <c:crosses val="autoZero"/>
        <c:crossBetween val="between"/>
      </c:valAx>
    </c:plotArea>
    <c:legend>
      <c:legendPos val="r"/>
      <c:overlay val="0"/>
    </c:legend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nl-NL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1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val>
            <c:numRef>
              <c:f>'molecular funtion'!$F$13:$F$22</c:f>
              <c:numCache>
                <c:formatCode>General</c:formatCode>
                <c:ptCount val="10"/>
                <c:pt idx="0">
                  <c:v>124</c:v>
                </c:pt>
                <c:pt idx="1">
                  <c:v>124</c:v>
                </c:pt>
                <c:pt idx="2">
                  <c:v>124</c:v>
                </c:pt>
                <c:pt idx="3">
                  <c:v>124</c:v>
                </c:pt>
                <c:pt idx="4">
                  <c:v>50</c:v>
                </c:pt>
                <c:pt idx="5">
                  <c:v>26</c:v>
                </c:pt>
                <c:pt idx="6">
                  <c:v>23</c:v>
                </c:pt>
                <c:pt idx="7">
                  <c:v>124</c:v>
                </c:pt>
                <c:pt idx="8">
                  <c:v>12</c:v>
                </c:pt>
                <c:pt idx="9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0E1-4096-8D0C-8144EB53A3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8"/>
        <c:axId val="812890344"/>
        <c:axId val="885918952"/>
      </c:barChart>
      <c:lineChart>
        <c:grouping val="standard"/>
        <c:varyColors val="0"/>
        <c:ser>
          <c:idx val="1"/>
          <c:order val="0"/>
          <c:spPr>
            <a:ln>
              <a:solidFill>
                <a:srgbClr val="FF0000"/>
              </a:solidFill>
            </a:ln>
          </c:spPr>
          <c:marker>
            <c:symbol val="none"/>
          </c:marker>
          <c:cat>
            <c:strRef>
              <c:f>'molecular funtion'!$A$13:$A$22</c:f>
              <c:strCache>
                <c:ptCount val="10"/>
                <c:pt idx="0">
                  <c:v>RNA binding </c:v>
                </c:pt>
                <c:pt idx="1">
                  <c:v>Nucleic acid binding </c:v>
                </c:pt>
                <c:pt idx="2">
                  <c:v>Heterocyclic compound binding </c:v>
                </c:pt>
                <c:pt idx="3">
                  <c:v>Organic cyclic compound binding </c:v>
                </c:pt>
                <c:pt idx="4">
                  <c:v>mRNA binding </c:v>
                </c:pt>
                <c:pt idx="5">
                  <c:v>mRNA 3'-UTR binding </c:v>
                </c:pt>
                <c:pt idx="6">
                  <c:v>Single-stranded RNA binding </c:v>
                </c:pt>
                <c:pt idx="7">
                  <c:v>Binding </c:v>
                </c:pt>
                <c:pt idx="8">
                  <c:v>RNA-dependent ATPase activity </c:v>
                </c:pt>
                <c:pt idx="9">
                  <c:v>RNA helicase activity </c:v>
                </c:pt>
              </c:strCache>
            </c:strRef>
          </c:cat>
          <c:val>
            <c:numRef>
              <c:f>'molecular funtion'!$L$13:$L$22</c:f>
              <c:numCache>
                <c:formatCode>General</c:formatCode>
                <c:ptCount val="10"/>
                <c:pt idx="0">
                  <c:v>129.07468790850035</c:v>
                </c:pt>
                <c:pt idx="1">
                  <c:v>81.603800652904269</c:v>
                </c:pt>
                <c:pt idx="2">
                  <c:v>61.378823718224965</c:v>
                </c:pt>
                <c:pt idx="3">
                  <c:v>60.737548910269574</c:v>
                </c:pt>
                <c:pt idx="4">
                  <c:v>56.721246399047168</c:v>
                </c:pt>
                <c:pt idx="5">
                  <c:v>31.801342913045577</c:v>
                </c:pt>
                <c:pt idx="6">
                  <c:v>25.962573502059378</c:v>
                </c:pt>
                <c:pt idx="7">
                  <c:v>12.87942606879415</c:v>
                </c:pt>
                <c:pt idx="8">
                  <c:v>12.603800652904264</c:v>
                </c:pt>
                <c:pt idx="9">
                  <c:v>12.2588484011482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0E1-4096-8D0C-8144EB53A3A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12890344"/>
        <c:axId val="885918952"/>
      </c:lineChart>
      <c:valAx>
        <c:axId val="8859189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crossAx val="812890344"/>
        <c:crosses val="autoZero"/>
        <c:crossBetween val="between"/>
      </c:valAx>
      <c:catAx>
        <c:axId val="81289034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 rot="-5400000" vert="horz"/>
          <a:lstStyle/>
          <a:p>
            <a:pPr>
              <a:defRPr/>
            </a:pPr>
            <a:endParaRPr lang="nl-NL"/>
          </a:p>
        </c:txPr>
        <c:crossAx val="88591895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700"/>
      </a:pPr>
      <a:endParaRPr lang="nl-NL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CA6BBA-E1BE-4579-BF86-99327413F3E3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D900E3-42B9-49DC-B81B-FC6B1116F2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26097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7D900E3-42B9-49DC-B81B-FC6B1116F2E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82470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4837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98687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9698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293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6747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099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410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02466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540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8677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5542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5AFB6-9B44-4BC3-B3B2-7C6044D1C4BC}" type="datetimeFigureOut">
              <a:rPr lang="en-GB" smtClean="0"/>
              <a:t>24/1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52B721-3C3C-497C-BD3D-74C9AFA64C9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398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2.xml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 rot="16200000">
            <a:off x="4077280" y="1106641"/>
            <a:ext cx="11224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ptide count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0" y="-27384"/>
            <a:ext cx="4532010" cy="34163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				          C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GB" dirty="0"/>
              <a:t>B				          D</a:t>
            </a:r>
            <a:endParaRPr lang="en-US" dirty="0"/>
          </a:p>
        </p:txBody>
      </p:sp>
      <p:cxnSp>
        <p:nvCxnSpPr>
          <p:cNvPr id="7" name="Straight Connector 6"/>
          <p:cNvCxnSpPr/>
          <p:nvPr/>
        </p:nvCxnSpPr>
        <p:spPr>
          <a:xfrm>
            <a:off x="539552" y="2678723"/>
            <a:ext cx="9361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763688" y="2678723"/>
            <a:ext cx="165618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827584" y="2678723"/>
            <a:ext cx="20120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oC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                     C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432" y="723239"/>
            <a:ext cx="3321528" cy="18834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TextBox 12"/>
          <p:cNvSpPr txBox="1"/>
          <p:nvPr/>
        </p:nvSpPr>
        <p:spPr>
          <a:xfrm>
            <a:off x="318454" y="506788"/>
            <a:ext cx="35317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   MB MT  MB  MT     L   MB   L    MT   L    MB   L    MT 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Straight Connector 13"/>
          <p:cNvCxnSpPr/>
          <p:nvPr/>
        </p:nvCxnSpPr>
        <p:spPr>
          <a:xfrm>
            <a:off x="539552" y="491912"/>
            <a:ext cx="4265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043608" y="491912"/>
            <a:ext cx="42652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841220" y="491912"/>
            <a:ext cx="714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/>
          <p:cNvCxnSpPr/>
          <p:nvPr/>
        </p:nvCxnSpPr>
        <p:spPr>
          <a:xfrm>
            <a:off x="2843808" y="491912"/>
            <a:ext cx="71455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611560" y="267236"/>
            <a:ext cx="2924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C       DMD	              HC	               DMD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49C23AA-C665-4311-BD47-04AA60FCADDE}"/>
              </a:ext>
            </a:extLst>
          </p:cNvPr>
          <p:cNvSpPr txBox="1"/>
          <p:nvPr/>
        </p:nvSpPr>
        <p:spPr>
          <a:xfrm>
            <a:off x="1525446" y="4953229"/>
            <a:ext cx="1281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og</a:t>
            </a:r>
            <a:r>
              <a:rPr lang="en-US" sz="1200" baseline="-25000" dirty="0"/>
              <a:t>2</a:t>
            </a:r>
            <a:r>
              <a:rPr lang="en-US" sz="1200" dirty="0"/>
              <a:t> FC (CL/</a:t>
            </a:r>
            <a:r>
              <a:rPr lang="en-US" sz="1200" dirty="0" err="1"/>
              <a:t>noCL</a:t>
            </a:r>
            <a:r>
              <a:rPr lang="en-US" sz="1200" dirty="0"/>
              <a:t>)</a:t>
            </a:r>
            <a:endParaRPr lang="nl-NL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87A8E37-19E7-451A-AE13-94688050941C}"/>
              </a:ext>
            </a:extLst>
          </p:cNvPr>
          <p:cNvSpPr txBox="1"/>
          <p:nvPr/>
        </p:nvSpPr>
        <p:spPr>
          <a:xfrm rot="16200000">
            <a:off x="-221816" y="3714465"/>
            <a:ext cx="10352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-Log</a:t>
            </a:r>
            <a:r>
              <a:rPr lang="en-US" sz="1200" baseline="-25000" dirty="0"/>
              <a:t>10</a:t>
            </a:r>
            <a:r>
              <a:rPr lang="en-US" sz="1200" dirty="0"/>
              <a:t> </a:t>
            </a:r>
            <a:r>
              <a:rPr lang="en-US" sz="1200" i="1" dirty="0"/>
              <a:t>P </a:t>
            </a:r>
            <a:r>
              <a:rPr lang="en-US" sz="1200" dirty="0"/>
              <a:t>value</a:t>
            </a:r>
            <a:endParaRPr lang="nl-NL" sz="1200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5157C094-0699-4706-82D9-DD2760C533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7544" y="3153029"/>
            <a:ext cx="3271450" cy="171463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AEB9812F-1EDE-4241-B95E-9152D1B07994}"/>
              </a:ext>
            </a:extLst>
          </p:cNvPr>
          <p:cNvSpPr txBox="1"/>
          <p:nvPr/>
        </p:nvSpPr>
        <p:spPr>
          <a:xfrm rot="16200000">
            <a:off x="3736746" y="3829850"/>
            <a:ext cx="1736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count / 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lang="en-US" sz="1000" baseline="-25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FDR</a:t>
            </a:r>
            <a:endParaRPr lang="en-GB" sz="10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41468D2-4723-472D-A382-88FE181D1C78}"/>
              </a:ext>
            </a:extLst>
          </p:cNvPr>
          <p:cNvSpPr txBox="1"/>
          <p:nvPr/>
        </p:nvSpPr>
        <p:spPr>
          <a:xfrm>
            <a:off x="125544" y="99987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250</a:t>
            </a:r>
            <a:endParaRPr lang="nl-NL" sz="7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74EDC2B-DC2D-42BC-9EDE-C7DCA0EAA011}"/>
              </a:ext>
            </a:extLst>
          </p:cNvPr>
          <p:cNvSpPr txBox="1"/>
          <p:nvPr/>
        </p:nvSpPr>
        <p:spPr>
          <a:xfrm>
            <a:off x="125544" y="119992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30</a:t>
            </a:r>
            <a:endParaRPr lang="nl-NL" sz="7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48C08D0-4714-4561-B533-D480F19D0A86}"/>
              </a:ext>
            </a:extLst>
          </p:cNvPr>
          <p:cNvSpPr txBox="1"/>
          <p:nvPr/>
        </p:nvSpPr>
        <p:spPr>
          <a:xfrm>
            <a:off x="125544" y="136318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00</a:t>
            </a:r>
            <a:endParaRPr lang="nl-NL" sz="7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74AC1FC-2157-4063-8127-0AB185844173}"/>
              </a:ext>
            </a:extLst>
          </p:cNvPr>
          <p:cNvSpPr txBox="1"/>
          <p:nvPr/>
        </p:nvSpPr>
        <p:spPr>
          <a:xfrm>
            <a:off x="170428" y="149990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70</a:t>
            </a:r>
            <a:endParaRPr lang="nl-NL" sz="7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0480544-B8AC-4E6D-9226-53D7C8696A51}"/>
              </a:ext>
            </a:extLst>
          </p:cNvPr>
          <p:cNvSpPr txBox="1"/>
          <p:nvPr/>
        </p:nvSpPr>
        <p:spPr>
          <a:xfrm>
            <a:off x="170428" y="167619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55</a:t>
            </a:r>
            <a:endParaRPr lang="nl-NL" sz="7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4A26EAF-88D6-498F-9E76-01914F37D1A0}"/>
              </a:ext>
            </a:extLst>
          </p:cNvPr>
          <p:cNvSpPr txBox="1"/>
          <p:nvPr/>
        </p:nvSpPr>
        <p:spPr>
          <a:xfrm>
            <a:off x="170428" y="197094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35</a:t>
            </a:r>
            <a:endParaRPr lang="nl-NL" sz="7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460C688-3C07-40DB-B08E-ACB22EED8BCD}"/>
              </a:ext>
            </a:extLst>
          </p:cNvPr>
          <p:cNvSpPr txBox="1"/>
          <p:nvPr/>
        </p:nvSpPr>
        <p:spPr>
          <a:xfrm>
            <a:off x="170428" y="212553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25</a:t>
            </a:r>
            <a:endParaRPr lang="nl-NL" sz="7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F857DC4-FEEA-41C0-A9AC-5E34DED912E2}"/>
              </a:ext>
            </a:extLst>
          </p:cNvPr>
          <p:cNvSpPr txBox="1"/>
          <p:nvPr/>
        </p:nvSpPr>
        <p:spPr>
          <a:xfrm>
            <a:off x="3594621" y="104221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250</a:t>
            </a:r>
            <a:endParaRPr lang="nl-NL" sz="7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BA4C864-BDE2-4658-B27B-1F9C81704D4E}"/>
              </a:ext>
            </a:extLst>
          </p:cNvPr>
          <p:cNvSpPr txBox="1"/>
          <p:nvPr/>
        </p:nvSpPr>
        <p:spPr>
          <a:xfrm>
            <a:off x="3594621" y="122322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30</a:t>
            </a:r>
            <a:endParaRPr lang="nl-NL" sz="7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0D013E5-F82E-4754-B893-1A6E6290CEE6}"/>
              </a:ext>
            </a:extLst>
          </p:cNvPr>
          <p:cNvSpPr txBox="1"/>
          <p:nvPr/>
        </p:nvSpPr>
        <p:spPr>
          <a:xfrm>
            <a:off x="3594621" y="139600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100</a:t>
            </a:r>
            <a:endParaRPr lang="nl-NL" sz="7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46641C-7ED4-4AE6-99C8-498675988B80}"/>
              </a:ext>
            </a:extLst>
          </p:cNvPr>
          <p:cNvSpPr txBox="1"/>
          <p:nvPr/>
        </p:nvSpPr>
        <p:spPr>
          <a:xfrm>
            <a:off x="3594621" y="154225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70</a:t>
            </a:r>
            <a:endParaRPr lang="nl-NL" sz="7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70E2EFC-7E00-4AA1-93AB-0FEEB00710E4}"/>
              </a:ext>
            </a:extLst>
          </p:cNvPr>
          <p:cNvSpPr txBox="1"/>
          <p:nvPr/>
        </p:nvSpPr>
        <p:spPr>
          <a:xfrm>
            <a:off x="3594621" y="170266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55</a:t>
            </a:r>
            <a:endParaRPr lang="nl-NL" sz="7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6BD80A8-EC46-4709-AD03-BDF1940D1FD9}"/>
              </a:ext>
            </a:extLst>
          </p:cNvPr>
          <p:cNvSpPr txBox="1"/>
          <p:nvPr/>
        </p:nvSpPr>
        <p:spPr>
          <a:xfrm>
            <a:off x="3594621" y="198789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35</a:t>
            </a:r>
            <a:endParaRPr lang="nl-NL" sz="7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4D0C9EC-8065-433B-A872-FC36D20934A8}"/>
              </a:ext>
            </a:extLst>
          </p:cNvPr>
          <p:cNvSpPr txBox="1"/>
          <p:nvPr/>
        </p:nvSpPr>
        <p:spPr>
          <a:xfrm>
            <a:off x="3594621" y="214247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/>
              <a:t>25</a:t>
            </a:r>
            <a:endParaRPr lang="nl-NL" sz="700" dirty="0"/>
          </a:p>
        </p:txBody>
      </p: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57786669"/>
              </p:ext>
            </p:extLst>
          </p:nvPr>
        </p:nvGraphicFramePr>
        <p:xfrm>
          <a:off x="4743433" y="328762"/>
          <a:ext cx="4335388" cy="25345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8" name="Chart 37">
            <a:extLst>
              <a:ext uri="{FF2B5EF4-FFF2-40B4-BE49-F238E27FC236}">
                <a16:creationId xmlns:a16="http://schemas.microsoft.com/office/drawing/2014/main" id="{3BCEB501-7F61-40A5-9BAD-5CFF6031E15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02034388"/>
              </p:ext>
            </p:extLst>
          </p:nvPr>
        </p:nvGraphicFramePr>
        <p:xfrm>
          <a:off x="4797364" y="3084773"/>
          <a:ext cx="3423452" cy="29610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" name="矩形 3"/>
          <p:cNvSpPr/>
          <p:nvPr/>
        </p:nvSpPr>
        <p:spPr>
          <a:xfrm>
            <a:off x="5940152" y="6045833"/>
            <a:ext cx="171232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GO molecular function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7409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77</TotalTime>
  <Words>77</Words>
  <Application>Microsoft Office PowerPoint</Application>
  <PresentationFormat>On-screen Show (4:3)</PresentationFormat>
  <Paragraphs>3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U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pitali, P. (HG)</dc:creator>
  <cp:lastModifiedBy>Spitali, P. (HG)</cp:lastModifiedBy>
  <cp:revision>252</cp:revision>
  <dcterms:created xsi:type="dcterms:W3CDTF">2018-04-30T14:21:34Z</dcterms:created>
  <dcterms:modified xsi:type="dcterms:W3CDTF">2020-11-24T13:59:16Z</dcterms:modified>
</cp:coreProperties>
</file>